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72" y="27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1/07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121544" y="2987824"/>
            <a:ext cx="6522415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Suplemental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1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number of reads in each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brary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the insert size </a:t>
            </a:r>
            <a:endParaRPr lang="en-US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range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968" y="3455657"/>
            <a:ext cx="6435992" cy="40240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499194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22</Words>
  <Application>Microsoft Office PowerPoint</Application>
  <PresentationFormat>Presentación en pantalla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Carmen</dc:creator>
  <cp:lastModifiedBy>MariCarmen</cp:lastModifiedBy>
  <cp:revision>8</cp:revision>
  <dcterms:created xsi:type="dcterms:W3CDTF">2013-08-20T11:25:41Z</dcterms:created>
  <dcterms:modified xsi:type="dcterms:W3CDTF">2014-07-21T09:47:08Z</dcterms:modified>
</cp:coreProperties>
</file>